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58" r:id="rId4"/>
    <p:sldId id="259" r:id="rId5"/>
    <p:sldId id="257" r:id="rId6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8493" autoAdjust="0"/>
  </p:normalViewPr>
  <p:slideViewPr>
    <p:cSldViewPr snapToGrid="0">
      <p:cViewPr varScale="1">
        <p:scale>
          <a:sx n="57" d="100"/>
          <a:sy n="57" d="100"/>
        </p:scale>
        <p:origin x="123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24FEE2-486A-4B7A-B936-963A335F33E4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4B30B5-E181-4CD0-8C5C-98414A8E01CE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71131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a </a:t>
            </a:r>
            <a:r>
              <a:rPr lang="en-US" dirty="0"/>
              <a:t>Forest plot for the comparison of circulating FGF-21 between patients with NAFLD and controls, in sensitivity analysis after excluding studies with pediatric/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olescent populations</a:t>
            </a:r>
            <a:endParaRPr lang="en-US" dirty="0"/>
          </a:p>
          <a:p>
            <a:r>
              <a:rPr lang="en-US" dirty="0"/>
              <a:t>Abbreviations: CI, confidence intervals; FGF-21, fibroblast growth factor-21; IV, inverse variance; MAFLD, metabolic-dysfunction associated fatty liver disease; NAFLD, nonalcoholic fatty liver disease; n, number of excluded studies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4B30B5-E181-4CD0-8C5C-98414A8E01CE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407497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b </a:t>
            </a:r>
            <a:r>
              <a:rPr lang="en-US" dirty="0"/>
              <a:t>Forest plot for the comparison of circulating FGF-21 between patients with NAFLD and controls, in sensitivity analysis after excluding studies wit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rbidly obese populations subjected to bariatric surgery</a:t>
            </a:r>
            <a:endParaRPr lang="en-US" dirty="0"/>
          </a:p>
          <a:p>
            <a:r>
              <a:rPr lang="en-US" dirty="0"/>
              <a:t>Abbreviations: CI, confidence intervals; FGF-21, fibroblast growth factor-21; IV, inverse variance; NAFLD, nonalcoholic fatty liver disease; n, number of excluded studies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4B30B5-E181-4CD0-8C5C-98414A8E01CE}" type="slidenum">
              <a:rPr lang="el-GR" smtClean="0"/>
              <a:t>2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180849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c </a:t>
            </a:r>
            <a:r>
              <a:rPr lang="en-US" dirty="0"/>
              <a:t>Forest plot for the comparison of circulating FGF-21 between patients with NAFLD and controls, in sensitivity analysis after excluding studies with NOS score &lt;7</a:t>
            </a:r>
          </a:p>
          <a:p>
            <a:r>
              <a:rPr lang="en-US" dirty="0"/>
              <a:t>Abbreviations: CI, confidence intervals; FGF-21, fibroblast growth factor-21; IV, inverse variance; MAFLD, metabolic-dysfunction associated fatty liver disease; NAFLD, nonalcoholic fatty liver disease; NOS, Newcastle Ottawa scale; n, number of excluded studies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4B30B5-E181-4CD0-8C5C-98414A8E01CE}" type="slidenum">
              <a:rPr lang="el-GR" smtClean="0"/>
              <a:t>3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408347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d </a:t>
            </a:r>
            <a:r>
              <a:rPr lang="en-US" dirty="0"/>
              <a:t>Forest plot for the comparison of circulating FGF-21 between patients with NAFLD and controls, in sensitivity analysis after excluding studies with </a:t>
            </a:r>
            <a:r>
              <a:rPr lang="en-US" sz="12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utliers of FGF-21 SMD</a:t>
            </a:r>
            <a:endParaRPr lang="en-US" dirty="0"/>
          </a:p>
          <a:p>
            <a:r>
              <a:rPr lang="en-US" dirty="0"/>
              <a:t>Abbreviations: CI, confidence intervals; FGF-21, fibroblast growth factor-21; IV, inverse variance; MAFLD, metabolic-dysfunction associated fatty liver disease; NAFLD, nonalcoholic fatty liver disease; n, number of excluded studies; SD, standard deviation; SMD, standardized mean difference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4B30B5-E181-4CD0-8C5C-98414A8E01CE}" type="slidenum">
              <a:rPr lang="el-GR" smtClean="0"/>
              <a:t>4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115351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e </a:t>
            </a:r>
            <a:r>
              <a:rPr lang="en-US" dirty="0"/>
              <a:t>Forest plot for the comparison of circulating FGF-21 between patients with NAFLD and controls, in sensitivity analysis after excluding studies with </a:t>
            </a:r>
            <a:r>
              <a:rPr lang="en-US" sz="12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he use of the definition of MAFLD for the diagnosis of the disease</a:t>
            </a:r>
            <a:endParaRPr lang="en-US" dirty="0"/>
          </a:p>
          <a:p>
            <a:r>
              <a:rPr lang="en-US" dirty="0"/>
              <a:t>Abbreviations: CI, confidence intervals; FGF-21, fibroblast growth factor-21; IV, inverse variance; MAFLD, metabolic-dysfunction associated fatty liver disease; NAFLD, nonalcoholic fatty liver disease; n, number of excluded studies; SD, </a:t>
            </a:r>
            <a:r>
              <a:rPr lang="en-US"/>
              <a:t>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4B30B5-E181-4CD0-8C5C-98414A8E01CE}" type="slidenum">
              <a:rPr lang="el-GR" smtClean="0"/>
              <a:t>5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739183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0AB85EC-4797-2085-BFA0-AA45E7BA7F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81278D0B-76CC-1F33-569B-CEE2AD9F1D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528325B1-00FF-8936-BA6B-DE982FDCD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3DA3B21B-E07B-1EF3-3026-E23457B98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B1513B2-52BB-44CA-E491-70B6EF96B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2062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96DFE22-6C97-CF56-1CB7-0DF6A3596E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77AD5AA3-3EF2-A9AF-527F-97928D70C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EFD61769-BE7B-A2B9-94C2-D8CB7FBBA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08CDCF95-9D02-F906-33DD-440A53B08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B216E11B-042D-F70C-69A2-F348C2E04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419597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846EF41D-B71C-D8D9-D5DD-D705F71727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1F2D5DA6-B3A5-5E95-2907-906521897E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9A158A9A-04FA-B99E-1B7E-D295A8994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760D4A2F-A363-6309-A4E9-E6574324D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28276E5D-E6B5-6736-1D5A-F5A201CA3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65947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538FBB2B-E18A-8075-CCEF-0D70C4A4A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BA3D9E31-FB53-B899-A629-6C58F56D0B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90C6BDD-5933-9C57-FE06-0CF75F542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7B66B375-F5CB-853B-8BD7-023FBE869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102C67D5-B0A6-EB25-F8B7-A5A8F25EF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59136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EAE2E68-4A54-59C1-9564-9D2B5D9A0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B3948037-1501-4AD9-510D-AB6842B953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457786F2-5920-4D97-4FAC-587A1E356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0F7D112-8133-29F5-E162-95AED552E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F5B63368-F1C5-E697-D251-F0839730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2339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F6C3474-1DA8-CDEE-9FEC-64ED0BA44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8A57FDB0-0265-FFC3-F1C5-4FFB5AE3DF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A67B78A5-958A-5FEC-F626-D780137947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97C2F5C9-BA9A-62D8-9061-B72FFE9C9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6C8B2811-85CB-53A9-0843-DA8471ACE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E7B2A7A1-D38D-ED1D-4030-E9E327353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28232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3CBFFD66-EE11-A8D1-5E5D-384AFAB43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E9E19C54-63A4-4DA9-0B8B-4DD86093C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C299B664-BE69-8F2E-F153-7219A7E49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AF4AAAA9-2E64-054A-61CF-CDA2C76D00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BC66EFA7-A34B-A6F8-CA8E-EB6CE7730D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4AB62734-F264-FEC0-32F3-12A7E6CE4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ACE0E857-CF43-98DF-4EA4-9335C3B6B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5EF1E04D-B4FB-5E08-8C39-F8E5EA4C7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78568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585440F-9AE1-D367-DE24-2EB836F637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DE6CEA4D-C142-B5CB-1C67-72C625573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9DC216B1-5017-6583-6DFD-7A37FB28A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447F1136-4991-56B0-7978-5A9575ECF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36072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5CD32A87-534D-2ECB-4724-3ADECB4AF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8A27F8C8-8499-5AF8-CFBE-F1CBFBCF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148AD4F1-F139-F666-E5A8-8B90E67D7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19589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F6FB1D8-CE67-79E2-CFF8-73FE1F355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23B23D90-270C-22CE-2C32-56EBBA1526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694A1D5F-25AF-62DE-3A85-57FB78155F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02970510-4572-BAE8-58B8-BEF4346ED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70A2CED4-1457-6E0F-5C9B-460D5E852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E78ACAC3-FAED-1CBB-0AA0-DB81B6E7F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2581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1FE20F5-9DFA-52A0-D0F4-3573B739F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85D05CD5-6FA9-6DFE-908B-D105476077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DC1A91AA-5182-0BE9-2B19-5D13221342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E3D3874D-0951-2296-F634-25C488921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EFF40B61-6962-A1EE-A125-E6947B6F1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64E1554C-3F10-483E-C0B0-90D36CAB9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02190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CB182DA7-BB0D-6333-36CF-FE82106004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5F4DEBFF-8C1A-62C7-3905-0E16923702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DF204CA-5514-422C-6252-AF4ECE7462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02ECA-8364-4CD8-A0AB-B52B35A6EDDA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76580DDD-6407-8152-DF71-E77CBA6D9A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F54D6C78-A5B9-86FF-D249-330C95B69D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A48B9-B99F-4F3B-B5DA-AF0A72D23DB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71360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Θέση περιεχομένου 6">
            <a:extLst>
              <a:ext uri="{FF2B5EF4-FFF2-40B4-BE49-F238E27FC236}">
                <a16:creationId xmlns:a16="http://schemas.microsoft.com/office/drawing/2014/main" id="{598DEA38-B941-3A88-F1B5-5D643C47AA2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334" y="122019"/>
            <a:ext cx="7027333" cy="6613961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3F3747D-70D9-B27B-3337-14116FD3226A}"/>
              </a:ext>
            </a:extLst>
          </p:cNvPr>
          <p:cNvSpPr txBox="1"/>
          <p:nvPr/>
        </p:nvSpPr>
        <p:spPr>
          <a:xfrm>
            <a:off x="423333" y="5011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a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1593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015AF7AA-DE41-4EEA-775C-38DE7A7861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0463" y="143933"/>
            <a:ext cx="6980766" cy="657013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6E56AD6-ABB1-2F78-4544-A7C0814B32C6}"/>
              </a:ext>
            </a:extLst>
          </p:cNvPr>
          <p:cNvSpPr txBox="1"/>
          <p:nvPr/>
        </p:nvSpPr>
        <p:spPr>
          <a:xfrm>
            <a:off x="270933" y="53500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b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870273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Θέση περιεχομένου 10">
            <a:extLst>
              <a:ext uri="{FF2B5EF4-FFF2-40B4-BE49-F238E27FC236}">
                <a16:creationId xmlns:a16="http://schemas.microsoft.com/office/drawing/2014/main" id="{6F70515E-6899-6286-A197-1476C898B98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3673" y="208156"/>
            <a:ext cx="6844291" cy="6441687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7B1B314-232B-62E3-6453-1DCFED36F335}"/>
              </a:ext>
            </a:extLst>
          </p:cNvPr>
          <p:cNvSpPr txBox="1"/>
          <p:nvPr/>
        </p:nvSpPr>
        <p:spPr>
          <a:xfrm>
            <a:off x="457200" y="7043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c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589034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Θέση περιεχομένου 6">
            <a:extLst>
              <a:ext uri="{FF2B5EF4-FFF2-40B4-BE49-F238E27FC236}">
                <a16:creationId xmlns:a16="http://schemas.microsoft.com/office/drawing/2014/main" id="{6FCC799A-9FC3-187D-0600-D5B535A97E6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8216" y="158346"/>
            <a:ext cx="6926091" cy="6541308"/>
          </a:xfrm>
          <a:ln w="1905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2A0733A-E94E-1353-0298-E023CB0C9D2B}"/>
              </a:ext>
            </a:extLst>
          </p:cNvPr>
          <p:cNvSpPr txBox="1"/>
          <p:nvPr/>
        </p:nvSpPr>
        <p:spPr>
          <a:xfrm>
            <a:off x="541866" y="670467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d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7114952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DB869864-50F2-21EF-7976-9A2E825294F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6380" y="245416"/>
            <a:ext cx="6765115" cy="6367168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A8FF64-386D-006A-23B5-2E3F9B715463}"/>
              </a:ext>
            </a:extLst>
          </p:cNvPr>
          <p:cNvSpPr txBox="1"/>
          <p:nvPr/>
        </p:nvSpPr>
        <p:spPr>
          <a:xfrm>
            <a:off x="440267" y="68740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e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1092870976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</TotalTime>
  <Words>401</Words>
  <Application>Microsoft Office PowerPoint</Application>
  <PresentationFormat>Ευρεία οθόνη</PresentationFormat>
  <Paragraphs>20</Paragraphs>
  <Slides>5</Slides>
  <Notes>5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a fil</dc:creator>
  <cp:lastModifiedBy>Ioanna Filimidou</cp:lastModifiedBy>
  <cp:revision>19</cp:revision>
  <dcterms:created xsi:type="dcterms:W3CDTF">2024-12-11T13:36:39Z</dcterms:created>
  <dcterms:modified xsi:type="dcterms:W3CDTF">2025-02-27T21:02:07Z</dcterms:modified>
</cp:coreProperties>
</file>